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78" r:id="rId2"/>
  </p:sldIdLst>
  <p:sldSz cx="5759450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01">
          <p15:clr>
            <a:srgbClr val="A4A3A4"/>
          </p15:clr>
        </p15:guide>
        <p15:guide id="2" pos="181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35" autoAdjust="0"/>
    <p:restoredTop sz="96807" autoAdjust="0"/>
  </p:normalViewPr>
  <p:slideViewPr>
    <p:cSldViewPr snapToGrid="0">
      <p:cViewPr varScale="1">
        <p:scale>
          <a:sx n="56" d="100"/>
          <a:sy n="56" d="100"/>
        </p:scale>
        <p:origin x="1572" y="66"/>
      </p:cViewPr>
      <p:guideLst>
        <p:guide orient="horz" pos="1701"/>
        <p:guide pos="181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07543B-B4D7-4B7F-8243-417A0CF72D06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782763" y="1143000"/>
            <a:ext cx="32924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6CE194-B2B9-41E2-B41C-1844A03E2BB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802060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18339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1pPr>
    <a:lvl2pPr marL="259170" algn="l" defTabSz="518339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2pPr>
    <a:lvl3pPr marL="518339" algn="l" defTabSz="518339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3pPr>
    <a:lvl4pPr marL="777509" algn="l" defTabSz="518339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4pPr>
    <a:lvl5pPr marL="1036678" algn="l" defTabSz="518339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5pPr>
    <a:lvl6pPr marL="1295848" algn="l" defTabSz="518339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6pPr>
    <a:lvl7pPr marL="1555017" algn="l" defTabSz="518339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7pPr>
    <a:lvl8pPr marL="1814187" algn="l" defTabSz="518339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8pPr>
    <a:lvl9pPr marL="2073356" algn="l" defTabSz="518339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31962" y="883861"/>
            <a:ext cx="4895533" cy="1880235"/>
          </a:xfrm>
        </p:spPr>
        <p:txBody>
          <a:bodyPr anchor="b"/>
          <a:lstStyle>
            <a:lvl1pPr algn="ctr">
              <a:defRPr sz="377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19931" y="2836606"/>
            <a:ext cx="4319588" cy="1303912"/>
          </a:xfrm>
        </p:spPr>
        <p:txBody>
          <a:bodyPr/>
          <a:lstStyle>
            <a:lvl1pPr marL="0" indent="0" algn="ctr">
              <a:buNone/>
              <a:defRPr sz="1512"/>
            </a:lvl1pPr>
            <a:lvl2pPr marL="287990" indent="0" algn="ctr">
              <a:buNone/>
              <a:defRPr sz="1260"/>
            </a:lvl2pPr>
            <a:lvl3pPr marL="575981" indent="0" algn="ctr">
              <a:buNone/>
              <a:defRPr sz="1134"/>
            </a:lvl3pPr>
            <a:lvl4pPr marL="863971" indent="0" algn="ctr">
              <a:buNone/>
              <a:defRPr sz="1008"/>
            </a:lvl4pPr>
            <a:lvl5pPr marL="1151961" indent="0" algn="ctr">
              <a:buNone/>
              <a:defRPr sz="1008"/>
            </a:lvl5pPr>
            <a:lvl6pPr marL="1439951" indent="0" algn="ctr">
              <a:buNone/>
              <a:defRPr sz="1008"/>
            </a:lvl6pPr>
            <a:lvl7pPr marL="1727942" indent="0" algn="ctr">
              <a:buNone/>
              <a:defRPr sz="1008"/>
            </a:lvl7pPr>
            <a:lvl8pPr marL="2015932" indent="0" algn="ctr">
              <a:buNone/>
              <a:defRPr sz="1008"/>
            </a:lvl8pPr>
            <a:lvl9pPr marL="2303922" indent="0" algn="ctr">
              <a:buNone/>
              <a:defRPr sz="100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4BA61-9C48-43F6-8D88-F526C78B011C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F1737-0EA2-4B87-BD7D-E158E567788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33810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4BA61-9C48-43F6-8D88-F526C78B011C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F1737-0EA2-4B87-BD7D-E158E567788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543357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21610" y="287538"/>
            <a:ext cx="1241881" cy="457682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95966" y="287538"/>
            <a:ext cx="3653651" cy="457682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4BA61-9C48-43F6-8D88-F526C78B011C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F1737-0EA2-4B87-BD7D-E158E567788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16512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4BA61-9C48-43F6-8D88-F526C78B011C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F1737-0EA2-4B87-BD7D-E158E567788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406954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2963" y="1346421"/>
            <a:ext cx="4967526" cy="2246531"/>
          </a:xfrm>
        </p:spPr>
        <p:txBody>
          <a:bodyPr anchor="b"/>
          <a:lstStyle>
            <a:lvl1pPr>
              <a:defRPr sz="377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2963" y="3614203"/>
            <a:ext cx="4967526" cy="1181398"/>
          </a:xfrm>
        </p:spPr>
        <p:txBody>
          <a:bodyPr/>
          <a:lstStyle>
            <a:lvl1pPr marL="0" indent="0">
              <a:buNone/>
              <a:defRPr sz="1512">
                <a:solidFill>
                  <a:schemeClr val="tx1"/>
                </a:solidFill>
              </a:defRPr>
            </a:lvl1pPr>
            <a:lvl2pPr marL="28799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2pPr>
            <a:lvl3pPr marL="57598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3pPr>
            <a:lvl4pPr marL="86397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4pPr>
            <a:lvl5pPr marL="115196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5pPr>
            <a:lvl6pPr marL="143995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6pPr>
            <a:lvl7pPr marL="172794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7pPr>
            <a:lvl8pPr marL="201593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8pPr>
            <a:lvl9pPr marL="230392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4BA61-9C48-43F6-8D88-F526C78B011C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F1737-0EA2-4B87-BD7D-E158E567788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55212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95962" y="1437680"/>
            <a:ext cx="2447766" cy="34266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15722" y="1437680"/>
            <a:ext cx="2447766" cy="34266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4BA61-9C48-43F6-8D88-F526C78B011C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F1737-0EA2-4B87-BD7D-E158E567788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60801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287537"/>
            <a:ext cx="4967526" cy="104388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6716" y="1323917"/>
            <a:ext cx="2436517" cy="648831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90" indent="0">
              <a:buNone/>
              <a:defRPr sz="1260" b="1"/>
            </a:lvl2pPr>
            <a:lvl3pPr marL="575981" indent="0">
              <a:buNone/>
              <a:defRPr sz="1134" b="1"/>
            </a:lvl3pPr>
            <a:lvl4pPr marL="863971" indent="0">
              <a:buNone/>
              <a:defRPr sz="1008" b="1"/>
            </a:lvl4pPr>
            <a:lvl5pPr marL="1151961" indent="0">
              <a:buNone/>
              <a:defRPr sz="1008" b="1"/>
            </a:lvl5pPr>
            <a:lvl6pPr marL="1439951" indent="0">
              <a:buNone/>
              <a:defRPr sz="1008" b="1"/>
            </a:lvl6pPr>
            <a:lvl7pPr marL="1727942" indent="0">
              <a:buNone/>
              <a:defRPr sz="1008" b="1"/>
            </a:lvl7pPr>
            <a:lvl8pPr marL="2015932" indent="0">
              <a:buNone/>
              <a:defRPr sz="1008" b="1"/>
            </a:lvl8pPr>
            <a:lvl9pPr marL="2303922" indent="0">
              <a:buNone/>
              <a:defRPr sz="100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6716" y="1972748"/>
            <a:ext cx="2436517" cy="29016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915722" y="1323917"/>
            <a:ext cx="2448516" cy="648831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90" indent="0">
              <a:buNone/>
              <a:defRPr sz="1260" b="1"/>
            </a:lvl2pPr>
            <a:lvl3pPr marL="575981" indent="0">
              <a:buNone/>
              <a:defRPr sz="1134" b="1"/>
            </a:lvl3pPr>
            <a:lvl4pPr marL="863971" indent="0">
              <a:buNone/>
              <a:defRPr sz="1008" b="1"/>
            </a:lvl4pPr>
            <a:lvl5pPr marL="1151961" indent="0">
              <a:buNone/>
              <a:defRPr sz="1008" b="1"/>
            </a:lvl5pPr>
            <a:lvl6pPr marL="1439951" indent="0">
              <a:buNone/>
              <a:defRPr sz="1008" b="1"/>
            </a:lvl6pPr>
            <a:lvl7pPr marL="1727942" indent="0">
              <a:buNone/>
              <a:defRPr sz="1008" b="1"/>
            </a:lvl7pPr>
            <a:lvl8pPr marL="2015932" indent="0">
              <a:buNone/>
              <a:defRPr sz="1008" b="1"/>
            </a:lvl8pPr>
            <a:lvl9pPr marL="2303922" indent="0">
              <a:buNone/>
              <a:defRPr sz="100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915722" y="1972748"/>
            <a:ext cx="2448516" cy="29016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4BA61-9C48-43F6-8D88-F526C78B011C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F1737-0EA2-4B87-BD7D-E158E567788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98631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4BA61-9C48-43F6-8D88-F526C78B011C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F1737-0EA2-4B87-BD7D-E158E567788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833434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4BA61-9C48-43F6-8D88-F526C78B011C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F1737-0EA2-4B87-BD7D-E158E567788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289252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5" y="360045"/>
            <a:ext cx="1857573" cy="1260157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8516" y="777598"/>
            <a:ext cx="2915722" cy="3837980"/>
          </a:xfrm>
        </p:spPr>
        <p:txBody>
          <a:bodyPr/>
          <a:lstStyle>
            <a:lvl1pPr>
              <a:defRPr sz="2016"/>
            </a:lvl1pPr>
            <a:lvl2pPr>
              <a:defRPr sz="1764"/>
            </a:lvl2pPr>
            <a:lvl3pPr>
              <a:defRPr sz="1512"/>
            </a:lvl3pPr>
            <a:lvl4pPr>
              <a:defRPr sz="1260"/>
            </a:lvl4pPr>
            <a:lvl5pPr>
              <a:defRPr sz="1260"/>
            </a:lvl5pPr>
            <a:lvl6pPr>
              <a:defRPr sz="1260"/>
            </a:lvl6pPr>
            <a:lvl7pPr>
              <a:defRPr sz="1260"/>
            </a:lvl7pPr>
            <a:lvl8pPr>
              <a:defRPr sz="1260"/>
            </a:lvl8pPr>
            <a:lvl9pPr>
              <a:defRPr sz="12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5" y="1620202"/>
            <a:ext cx="1857573" cy="3001626"/>
          </a:xfrm>
        </p:spPr>
        <p:txBody>
          <a:bodyPr/>
          <a:lstStyle>
            <a:lvl1pPr marL="0" indent="0">
              <a:buNone/>
              <a:defRPr sz="1008"/>
            </a:lvl1pPr>
            <a:lvl2pPr marL="287990" indent="0">
              <a:buNone/>
              <a:defRPr sz="882"/>
            </a:lvl2pPr>
            <a:lvl3pPr marL="575981" indent="0">
              <a:buNone/>
              <a:defRPr sz="756"/>
            </a:lvl3pPr>
            <a:lvl4pPr marL="863971" indent="0">
              <a:buNone/>
              <a:defRPr sz="630"/>
            </a:lvl4pPr>
            <a:lvl5pPr marL="1151961" indent="0">
              <a:buNone/>
              <a:defRPr sz="630"/>
            </a:lvl5pPr>
            <a:lvl6pPr marL="1439951" indent="0">
              <a:buNone/>
              <a:defRPr sz="630"/>
            </a:lvl6pPr>
            <a:lvl7pPr marL="1727942" indent="0">
              <a:buNone/>
              <a:defRPr sz="630"/>
            </a:lvl7pPr>
            <a:lvl8pPr marL="2015932" indent="0">
              <a:buNone/>
              <a:defRPr sz="630"/>
            </a:lvl8pPr>
            <a:lvl9pPr marL="2303922" indent="0">
              <a:buNone/>
              <a:defRPr sz="6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4BA61-9C48-43F6-8D88-F526C78B011C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F1737-0EA2-4B87-BD7D-E158E567788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19971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5" y="360045"/>
            <a:ext cx="1857573" cy="1260157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448516" y="777598"/>
            <a:ext cx="2915722" cy="3837980"/>
          </a:xfrm>
        </p:spPr>
        <p:txBody>
          <a:bodyPr anchor="t"/>
          <a:lstStyle>
            <a:lvl1pPr marL="0" indent="0">
              <a:buNone/>
              <a:defRPr sz="2016"/>
            </a:lvl1pPr>
            <a:lvl2pPr marL="287990" indent="0">
              <a:buNone/>
              <a:defRPr sz="1764"/>
            </a:lvl2pPr>
            <a:lvl3pPr marL="575981" indent="0">
              <a:buNone/>
              <a:defRPr sz="1512"/>
            </a:lvl3pPr>
            <a:lvl4pPr marL="863971" indent="0">
              <a:buNone/>
              <a:defRPr sz="1260"/>
            </a:lvl4pPr>
            <a:lvl5pPr marL="1151961" indent="0">
              <a:buNone/>
              <a:defRPr sz="1260"/>
            </a:lvl5pPr>
            <a:lvl6pPr marL="1439951" indent="0">
              <a:buNone/>
              <a:defRPr sz="1260"/>
            </a:lvl6pPr>
            <a:lvl7pPr marL="1727942" indent="0">
              <a:buNone/>
              <a:defRPr sz="1260"/>
            </a:lvl7pPr>
            <a:lvl8pPr marL="2015932" indent="0">
              <a:buNone/>
              <a:defRPr sz="1260"/>
            </a:lvl8pPr>
            <a:lvl9pPr marL="2303922" indent="0">
              <a:buNone/>
              <a:defRPr sz="12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5" y="1620202"/>
            <a:ext cx="1857573" cy="3001626"/>
          </a:xfrm>
        </p:spPr>
        <p:txBody>
          <a:bodyPr/>
          <a:lstStyle>
            <a:lvl1pPr marL="0" indent="0">
              <a:buNone/>
              <a:defRPr sz="1008"/>
            </a:lvl1pPr>
            <a:lvl2pPr marL="287990" indent="0">
              <a:buNone/>
              <a:defRPr sz="882"/>
            </a:lvl2pPr>
            <a:lvl3pPr marL="575981" indent="0">
              <a:buNone/>
              <a:defRPr sz="756"/>
            </a:lvl3pPr>
            <a:lvl4pPr marL="863971" indent="0">
              <a:buNone/>
              <a:defRPr sz="630"/>
            </a:lvl4pPr>
            <a:lvl5pPr marL="1151961" indent="0">
              <a:buNone/>
              <a:defRPr sz="630"/>
            </a:lvl5pPr>
            <a:lvl6pPr marL="1439951" indent="0">
              <a:buNone/>
              <a:defRPr sz="630"/>
            </a:lvl6pPr>
            <a:lvl7pPr marL="1727942" indent="0">
              <a:buNone/>
              <a:defRPr sz="630"/>
            </a:lvl7pPr>
            <a:lvl8pPr marL="2015932" indent="0">
              <a:buNone/>
              <a:defRPr sz="630"/>
            </a:lvl8pPr>
            <a:lvl9pPr marL="2303922" indent="0">
              <a:buNone/>
              <a:defRPr sz="6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4BA61-9C48-43F6-8D88-F526C78B011C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F1737-0EA2-4B87-BD7D-E158E567788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16470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95962" y="287537"/>
            <a:ext cx="4967526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5962" y="1437680"/>
            <a:ext cx="4967526" cy="342667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95962" y="5005626"/>
            <a:ext cx="1295876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14BA61-9C48-43F6-8D88-F526C78B011C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07818" y="5005626"/>
            <a:ext cx="1943814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067612" y="5005626"/>
            <a:ext cx="1295876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6F1737-0EA2-4B87-BD7D-E158E567788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89483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575981" rtl="0" eaLnBrk="1" latinLnBrk="0" hangingPunct="1">
        <a:lnSpc>
          <a:spcPct val="90000"/>
        </a:lnSpc>
        <a:spcBef>
          <a:spcPct val="0"/>
        </a:spcBef>
        <a:buNone/>
        <a:defRPr sz="277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3995" indent="-143995" algn="l" defTabSz="575981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1764" kern="1200">
          <a:solidFill>
            <a:schemeClr val="tx1"/>
          </a:solidFill>
          <a:latin typeface="+mn-lt"/>
          <a:ea typeface="+mn-ea"/>
          <a:cs typeface="+mn-cs"/>
        </a:defRPr>
      </a:lvl1pPr>
      <a:lvl2pPr marL="431985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2pPr>
      <a:lvl3pPr marL="71997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100796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29595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58394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87193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15992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44791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1pPr>
      <a:lvl2pPr marL="287990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2pPr>
      <a:lvl3pPr marL="57598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3pPr>
      <a:lvl4pPr marL="86397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15196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43995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727942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015932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303922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18D80B1-BB10-436A-940B-C88A4DB101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6527" y="716773"/>
            <a:ext cx="1462931" cy="103171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6FCA464-BD6B-4B96-A61F-83D3351ACA5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47852" y="716773"/>
            <a:ext cx="1735707" cy="103171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015C057-04DE-4224-B12B-B3F26CD0315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6527" y="1773140"/>
            <a:ext cx="1462931" cy="103018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AEDCB02-6C23-491A-9019-702C5234FE2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47852" y="1771382"/>
            <a:ext cx="1462931" cy="1031711"/>
          </a:xfrm>
          <a:prstGeom prst="rect">
            <a:avLst/>
          </a:prstGeom>
        </p:spPr>
      </p:pic>
      <p:sp>
        <p:nvSpPr>
          <p:cNvPr id="9" name="13 CuadroTexto">
            <a:extLst>
              <a:ext uri="{FF2B5EF4-FFF2-40B4-BE49-F238E27FC236}">
                <a16:creationId xmlns:a16="http://schemas.microsoft.com/office/drawing/2014/main" id="{77CA0279-C1EA-4CF3-9565-24996752AF9A}"/>
              </a:ext>
            </a:extLst>
          </p:cNvPr>
          <p:cNvSpPr txBox="1"/>
          <p:nvPr/>
        </p:nvSpPr>
        <p:spPr>
          <a:xfrm>
            <a:off x="992726" y="267537"/>
            <a:ext cx="18262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>
              <a:defRPr sz="1400" b="1"/>
            </a:lvl1pPr>
          </a:lstStyle>
          <a:p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Figure 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9599EE4-79E7-48D2-9E2E-3ECA5EE00FF4}"/>
              </a:ext>
            </a:extLst>
          </p:cNvPr>
          <p:cNvSpPr txBox="1"/>
          <p:nvPr/>
        </p:nvSpPr>
        <p:spPr>
          <a:xfrm>
            <a:off x="708189" y="470957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74F4B1B-85EA-44CA-93E6-65B424490CFF}"/>
              </a:ext>
            </a:extLst>
          </p:cNvPr>
          <p:cNvSpPr txBox="1"/>
          <p:nvPr/>
        </p:nvSpPr>
        <p:spPr>
          <a:xfrm>
            <a:off x="708189" y="2821770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B18F799E-4BF8-48F7-BF98-907F3746BB5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68751" y="3037214"/>
            <a:ext cx="1776852" cy="1130768"/>
          </a:xfrm>
          <a:prstGeom prst="rect">
            <a:avLst/>
          </a:prstGeom>
        </p:spPr>
      </p:pic>
      <p:sp>
        <p:nvSpPr>
          <p:cNvPr id="2" name="1 Rectángulo"/>
          <p:cNvSpPr/>
          <p:nvPr/>
        </p:nvSpPr>
        <p:spPr>
          <a:xfrm>
            <a:off x="49340" y="4329641"/>
            <a:ext cx="5610225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sv-SE" sz="1000" b="1" dirty="0">
                <a:latin typeface="Arial" pitchFamily="34" charset="0"/>
                <a:cs typeface="Arial" pitchFamily="34" charset="0"/>
              </a:rPr>
              <a:t>Supplementary figure 2: A) 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Individual levels of IgG1, IgG2, IgG3, and IgG4 GADA subclasses shown as arbitrary units (AUs) over time in 3 follow up patient receiving an extra GAD-alum injections into the lymph-node. 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B) 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Individual percentage of activated CD4</a:t>
            </a:r>
            <a:r>
              <a:rPr lang="en-US" sz="1000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 and CD8</a:t>
            </a:r>
            <a:r>
              <a:rPr lang="en-US" sz="1000" baseline="30000" dirty="0">
                <a:latin typeface="Arial" pitchFamily="34" charset="0"/>
                <a:cs typeface="Arial" pitchFamily="34" charset="0"/>
              </a:rPr>
              <a:t>+ 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T cells after stimulation with GAD</a:t>
            </a:r>
            <a:r>
              <a:rPr lang="en-US" sz="1000" baseline="-25000" dirty="0">
                <a:latin typeface="Arial" pitchFamily="34" charset="0"/>
                <a:cs typeface="Arial" pitchFamily="34" charset="0"/>
              </a:rPr>
              <a:t>65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 (5 µg/ml) over time in 3 follow up patient receiving an extra GAD-alum injections into the lymph-node. Patient 5 (green line), patient 6 (red line) and patient 7 (blue line).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9" name="18 Imagen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6943" y="3034449"/>
            <a:ext cx="1441808" cy="11385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52014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</TotalTime>
  <Words>105</Words>
  <Application>Microsoft Office PowerPoint</Application>
  <PresentationFormat>Anpassad</PresentationFormat>
  <Paragraphs>4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 Puente Marin</dc:creator>
  <cp:lastModifiedBy>Johnny Ludvigsson</cp:lastModifiedBy>
  <cp:revision>15</cp:revision>
  <dcterms:created xsi:type="dcterms:W3CDTF">2021-04-09T12:15:58Z</dcterms:created>
  <dcterms:modified xsi:type="dcterms:W3CDTF">2021-08-23T09:40:52Z</dcterms:modified>
</cp:coreProperties>
</file>